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7772400" cy="10058400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-2016" y="-128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045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210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10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47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495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57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0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76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84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94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118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498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400431" y="1871691"/>
            <a:ext cx="5000368" cy="386184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68161" y="5733534"/>
            <a:ext cx="5375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curves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omparing OS in patients with different Child-Pugh grade.  Log-rank test demonstrated no significant association between OS and Child-Pugh grade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0866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6</TotalTime>
  <Words>35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g55</dc:creator>
  <cp:lastModifiedBy>Ryan T</cp:lastModifiedBy>
  <cp:revision>23</cp:revision>
  <cp:lastPrinted>2015-04-23T21:25:43Z</cp:lastPrinted>
  <dcterms:created xsi:type="dcterms:W3CDTF">2015-04-23T20:59:46Z</dcterms:created>
  <dcterms:modified xsi:type="dcterms:W3CDTF">2015-05-29T02:13:17Z</dcterms:modified>
</cp:coreProperties>
</file>